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C680BF-197E-49F9-B677-1E221B25D5C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C5F5FC-F59F-4D61-B54B-53028A313AD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553C36-09E3-4BDC-96D3-8C3ECD96819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27EEC5-D70C-419B-9DD6-6AF423DEFB3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B18D9C-A16D-4A8E-A75F-F60143237C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B6A198-2EDB-415A-A1E5-757A7C72920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460C76-DF13-4961-B3AD-2DF0534E3D7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61FEE3-3872-4ABA-8A78-6F3B239CB25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34B4B2-F1D2-4E79-A4EC-33E32CE9ABD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94AC09-B028-4170-8283-F6D4972E19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213EF0-57B4-45BD-8752-8C9AAEAF5B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4FD50B-C5C0-4351-B647-EB13DD9BE8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9130AD5-2103-4341-B1AB-A4ADDE91C05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905040" y="5562720"/>
            <a:ext cx="5029200" cy="255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orting Figure S3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Phenotype characterization of over-expression of rice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OsCYP96B4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  in Arabidopsis background and T-DNA insertion mutants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AtCYP96A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  and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AtCYP96A10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. (A) Compared with WT (left), reduced leaf size (right) was observed in transgenic Arabidopsis with over-expression of rice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OsCYP96B4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. (B) WT Arabidopsis at flowering stage (top) and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transgenic flowering Arabidopsis plants over-expressing rice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OsCYP96B4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(bottom). (C) No obvious difference was observed in both T-DNA insertion mutants 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atcyp96a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  and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atcyp96a10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when compared with WT. (D) Similar silique development was also observed among WT,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atcyp96a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 and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atcyp96a10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rcRect l="20076" t="11921" r="34231" b="30661"/>
          <a:stretch/>
        </p:blipFill>
        <p:spPr>
          <a:xfrm>
            <a:off x="4267080" y="2305080"/>
            <a:ext cx="1524240" cy="150480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2"/>
          <a:srcRect l="21708" t="6331" r="33434" b="39402"/>
          <a:stretch/>
        </p:blipFill>
        <p:spPr>
          <a:xfrm>
            <a:off x="4267080" y="990720"/>
            <a:ext cx="1524240" cy="137304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4267080" y="990720"/>
            <a:ext cx="466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Times New Roman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5" name=""/>
          <p:cNvGrpSpPr/>
          <p:nvPr/>
        </p:nvGrpSpPr>
        <p:grpSpPr>
          <a:xfrm>
            <a:off x="990720" y="990720"/>
            <a:ext cx="3200400" cy="2819160"/>
            <a:chOff x="990720" y="990720"/>
            <a:chExt cx="3200400" cy="2819160"/>
          </a:xfrm>
        </p:grpSpPr>
        <p:pic>
          <p:nvPicPr>
            <p:cNvPr id="46" name="" descr=""/>
            <p:cNvPicPr/>
            <p:nvPr/>
          </p:nvPicPr>
          <p:blipFill>
            <a:blip r:embed="rId3"/>
            <a:srcRect l="0" t="2020" r="0" b="3031"/>
            <a:stretch/>
          </p:blipFill>
          <p:spPr>
            <a:xfrm>
              <a:off x="990720" y="990720"/>
              <a:ext cx="3200400" cy="2819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" name=""/>
            <p:cNvSpPr/>
            <p:nvPr/>
          </p:nvSpPr>
          <p:spPr>
            <a:xfrm>
              <a:off x="990720" y="990720"/>
              <a:ext cx="297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Times New Roman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8" name=""/>
          <p:cNvSpPr/>
          <p:nvPr/>
        </p:nvSpPr>
        <p:spPr>
          <a:xfrm>
            <a:off x="885960" y="685800"/>
            <a:ext cx="1589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orting Figure S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" descr=""/>
          <p:cNvPicPr/>
          <p:nvPr/>
        </p:nvPicPr>
        <p:blipFill>
          <a:blip r:embed="rId4"/>
          <a:srcRect l="0" t="21827" r="0" b="7936"/>
          <a:stretch/>
        </p:blipFill>
        <p:spPr>
          <a:xfrm>
            <a:off x="990720" y="3857760"/>
            <a:ext cx="3200400" cy="1685880"/>
          </a:xfrm>
          <a:prstGeom prst="rect">
            <a:avLst/>
          </a:prstGeom>
          <a:ln w="0">
            <a:noFill/>
          </a:ln>
        </p:spPr>
      </p:pic>
      <p:pic>
        <p:nvPicPr>
          <p:cNvPr id="50" name="" descr=""/>
          <p:cNvPicPr/>
          <p:nvPr/>
        </p:nvPicPr>
        <p:blipFill>
          <a:blip r:embed="rId5"/>
          <a:srcRect l="31733" t="28597" r="34421" b="15472"/>
          <a:stretch/>
        </p:blipFill>
        <p:spPr>
          <a:xfrm>
            <a:off x="4267080" y="3862440"/>
            <a:ext cx="1524240" cy="1685880"/>
          </a:xfrm>
          <a:prstGeom prst="rect">
            <a:avLst/>
          </a:prstGeom>
          <a:ln w="0">
            <a:noFill/>
          </a:ln>
        </p:spPr>
      </p:pic>
      <p:sp>
        <p:nvSpPr>
          <p:cNvPr id="51" name=""/>
          <p:cNvSpPr/>
          <p:nvPr/>
        </p:nvSpPr>
        <p:spPr>
          <a:xfrm>
            <a:off x="990720" y="3886200"/>
            <a:ext cx="466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Times New Roman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4205160" y="3840120"/>
            <a:ext cx="466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Times New Roman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590840" y="350532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Times New Roman"/>
              </a:rPr>
              <a:t>W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743200" y="3505320"/>
            <a:ext cx="914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ffffff"/>
                </a:solidFill>
                <a:latin typeface="Times New Roman"/>
              </a:rPr>
              <a:t>oscyp96b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4829040" y="213372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Times New Roman"/>
              </a:rPr>
              <a:t>W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4648320" y="3505320"/>
            <a:ext cx="914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ffffff"/>
                </a:solidFill>
                <a:latin typeface="Times New Roman"/>
              </a:rPr>
              <a:t>oscyp96b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1295280" y="5324400"/>
            <a:ext cx="428760" cy="219600"/>
          </a:xfrm>
          <a:prstGeom prst="rect">
            <a:avLst/>
          </a:prstGeom>
          <a:solidFill>
            <a:srgbClr val="4d4d4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18360" bIns="1836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Times New Roman"/>
              </a:rPr>
              <a:t>W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2205000" y="5324760"/>
            <a:ext cx="771480" cy="219600"/>
          </a:xfrm>
          <a:prstGeom prst="rect">
            <a:avLst/>
          </a:prstGeom>
          <a:solidFill>
            <a:srgbClr val="4d4d4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18360" bIns="1836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ffffff"/>
                </a:solidFill>
                <a:latin typeface="Times New Roman"/>
                <a:ea typeface="SimSun"/>
              </a:rPr>
              <a:t>atcyp96a1</a:t>
            </a:r>
            <a:r>
              <a:rPr b="0" lang="en-US" sz="1200" spc="-1" strike="noStrike">
                <a:solidFill>
                  <a:srgbClr val="ffffff"/>
                </a:solidFill>
                <a:latin typeface="Times New Roman"/>
                <a:ea typeface="SimSu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4815000" y="4303800"/>
            <a:ext cx="428400" cy="21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18360" bIns="1836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Times New Roman"/>
              </a:rPr>
              <a:t>W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4648320" y="4656600"/>
            <a:ext cx="771480" cy="21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18360" bIns="1836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ffffff"/>
                </a:solidFill>
                <a:latin typeface="Times New Roman"/>
                <a:ea typeface="SimSun"/>
              </a:rPr>
              <a:t>atcyp96a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4718880" y="5037480"/>
            <a:ext cx="711000" cy="21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18360" bIns="1836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ffffff"/>
                </a:solidFill>
                <a:latin typeface="Times New Roman"/>
                <a:ea typeface="SimSun"/>
              </a:rPr>
              <a:t>atcyp96a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3271680" y="5324760"/>
            <a:ext cx="771840" cy="219600"/>
          </a:xfrm>
          <a:prstGeom prst="rect">
            <a:avLst/>
          </a:prstGeom>
          <a:solidFill>
            <a:srgbClr val="4d4d4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18360" bIns="1836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ffffff"/>
                </a:solidFill>
                <a:latin typeface="Times New Roman"/>
                <a:ea typeface="SimSun"/>
              </a:rPr>
              <a:t>atcyp96a10</a:t>
            </a:r>
            <a:r>
              <a:rPr b="0" lang="en-US" sz="1200" spc="-1" strike="noStrike">
                <a:solidFill>
                  <a:srgbClr val="ffffff"/>
                </a:solidFill>
                <a:latin typeface="Times New Roman"/>
                <a:ea typeface="SimSu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8-15T07:11:45Z</dcterms:created>
  <dc:creator>shuye</dc:creator>
  <dc:description/>
  <dc:language>en-US</dc:language>
  <cp:lastModifiedBy>shuye</cp:lastModifiedBy>
  <cp:lastPrinted>2011-08-17T02:26:05Z</cp:lastPrinted>
  <dcterms:modified xsi:type="dcterms:W3CDTF">2011-08-23T05:30:59Z</dcterms:modified>
  <cp:revision>11</cp:revision>
  <dc:subject/>
  <dc:title>Slide 1</dc:title>
</cp:coreProperties>
</file>